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9" d="100"/>
          <a:sy n="79" d="100"/>
        </p:scale>
        <p:origin x="821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A34723-923F-54CA-AAE0-130CDC9B3F6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DD1D667-3420-5ACC-7643-29F14733938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B36FF3-DC5D-FE0F-D355-5ED521D65B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CDF5C-60E8-4978-BFAD-173C36961D3A}" type="datetimeFigureOut">
              <a:rPr lang="en-GB" smtClean="0"/>
              <a:t>06/0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A24083-4FC2-CD73-A4D8-7B9139F6D8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6B3B30-0C21-F324-7CF6-51AE970511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374BF-2C56-44CE-89DC-D8C20D4253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10647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4DC60F-9591-C866-6F33-F92C178DBA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CD7685C-993A-A345-D018-EB54B518C3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5B39C1-5C3E-0AEA-E7ED-00822B236F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CDF5C-60E8-4978-BFAD-173C36961D3A}" type="datetimeFigureOut">
              <a:rPr lang="en-GB" smtClean="0"/>
              <a:t>06/0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E8E69C-E1A6-0CA8-4C52-93379128FD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68B8D7-07B1-1DE1-7625-D38CCB646D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374BF-2C56-44CE-89DC-D8C20D4253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4340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C4698D1-ACD8-77D9-A246-3C85DFB6691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600484A-AF3F-8449-A93C-95E42730FD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B79D51-129D-2937-F9A9-99CFC28699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CDF5C-60E8-4978-BFAD-173C36961D3A}" type="datetimeFigureOut">
              <a:rPr lang="en-GB" smtClean="0"/>
              <a:t>06/0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CEC155-CAF0-BEA3-B93B-0000BB2862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7E7FF8-CA0B-E08F-6275-6F54C9F432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374BF-2C56-44CE-89DC-D8C20D4253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909935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DF3DBC-4DEE-EE84-6ABF-03AB41524B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5F345C-5E3D-09C0-74CB-75599A33504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D7F84F-4C26-6EF3-B495-6BE03D13F9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CDF5C-60E8-4978-BFAD-173C36961D3A}" type="datetimeFigureOut">
              <a:rPr lang="en-GB" smtClean="0"/>
              <a:t>06/0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827CDD-C3FA-E706-872F-1AD016E74C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2A2B87-C70A-35AA-621D-ED9B37316D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374BF-2C56-44CE-89DC-D8C20D4253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69875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A249AA-EF33-94E7-708D-3F36DDE157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2A7210A-BAF1-6BE2-F9D4-980C50C019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3E49B3-6AFB-3FC8-1A05-4D56E65323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CDF5C-60E8-4978-BFAD-173C36961D3A}" type="datetimeFigureOut">
              <a:rPr lang="en-GB" smtClean="0"/>
              <a:t>06/0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31A71C-3AD1-C442-EF19-B446E94AB2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A7FAD5-B7E9-5B83-991F-21ACAF72F0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374BF-2C56-44CE-89DC-D8C20D4253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86671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BE926A-1421-3D69-DD39-F19FCC115D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7E8F26-8EC1-203D-1CA6-CB65EA27CE3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928E440-E30A-6127-0FC5-E242A61B10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073142-F9A2-B74F-97D2-A6E5C6D346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CDF5C-60E8-4978-BFAD-173C36961D3A}" type="datetimeFigureOut">
              <a:rPr lang="en-GB" smtClean="0"/>
              <a:t>06/02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0F269F3-3883-AC84-016B-627081E29B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36EB93-B2AB-17B2-47C5-11E3694DAC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374BF-2C56-44CE-89DC-D8C20D4253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63274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CB559D-302B-E300-5953-E3F412685F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70B21EC-4E2E-4562-557F-331A610DAB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1834BEC-AA63-2FA9-DFF6-53C487D883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C16DF76-275C-A08B-6E4C-EA0822F4B50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719ED5E-6E18-B1BF-4238-D720B896657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C1BF075-1205-4B61-3BF5-09F99D6733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CDF5C-60E8-4978-BFAD-173C36961D3A}" type="datetimeFigureOut">
              <a:rPr lang="en-GB" smtClean="0"/>
              <a:t>06/02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D229EAC-A6A0-2597-B96B-1405FA8F8A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AD94D58-B592-FDE3-EB7E-E7DAE3D893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374BF-2C56-44CE-89DC-D8C20D4253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00606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B53F69-A4DF-738D-A874-E151620EBC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C43B282-1585-158C-ED60-4EF654E8F5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CDF5C-60E8-4978-BFAD-173C36961D3A}" type="datetimeFigureOut">
              <a:rPr lang="en-GB" smtClean="0"/>
              <a:t>06/02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DE6AF85-7509-07CE-34BE-E32F197301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14533EF-B1D8-0E6E-0BDB-957D421A94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374BF-2C56-44CE-89DC-D8C20D4253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81211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39667D9-8494-C478-6267-D44625F36B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CDF5C-60E8-4978-BFAD-173C36961D3A}" type="datetimeFigureOut">
              <a:rPr lang="en-GB" smtClean="0"/>
              <a:t>06/02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5DA776F-C646-5A89-5675-116E31F4AB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08F064B-8E4B-05EB-46BA-61EF084ABD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374BF-2C56-44CE-89DC-D8C20D4253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83475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0F43BB-6BAE-DA23-B3D9-CE50E47705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7F5FAD-FDB5-3305-5096-C5E22A5BCF7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0FF969E-3BA4-C7AC-AC5C-287340ED08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C2A1AB-3116-0A11-4405-71A6B58B6F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CDF5C-60E8-4978-BFAD-173C36961D3A}" type="datetimeFigureOut">
              <a:rPr lang="en-GB" smtClean="0"/>
              <a:t>06/02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1F7919-10AD-E0AA-BD8D-1A69D4B95B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1A8B136-33CF-876F-0FE1-300399273B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374BF-2C56-44CE-89DC-D8C20D4253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95806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4F64BB-D48A-D971-01C1-B85A16050A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9C78EA8-96BB-9DB2-4B33-5AD3D9D0886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DA1BD56-158B-C57C-69CB-4DDF9D4070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6D5446-8EFA-5CF1-9ED3-EB853034C3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CDF5C-60E8-4978-BFAD-173C36961D3A}" type="datetimeFigureOut">
              <a:rPr lang="en-GB" smtClean="0"/>
              <a:t>06/02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8975B5-CE5F-F83C-6FAE-12E213A3E6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CFA981-DE56-FA08-4049-57C2962121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374BF-2C56-44CE-89DC-D8C20D4253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79330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5EAEA65-E5CD-063B-C6E0-F1E6657AD2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A3A59F-FE94-FF7B-927F-60F3363513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C10FCA-CE3F-1A6C-C75D-6F23532F77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E6CDF5C-60E8-4978-BFAD-173C36961D3A}" type="datetimeFigureOut">
              <a:rPr lang="en-GB" smtClean="0"/>
              <a:t>06/0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84C7E8-9246-F71B-871F-38DF1FE9A1B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A295A1-57EE-DD46-6A73-18CC97B0DA5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4F374BF-2C56-44CE-89DC-D8C20D4253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19162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0ADC5D9D-AD8F-9EEB-F040-173448CFE1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pic>
        <p:nvPicPr>
          <p:cNvPr id="1028" name="Resim 1" descr="A screenshot of a computer&#10;&#10;Description automatically generated">
            <a:extLst>
              <a:ext uri="{FF2B5EF4-FFF2-40B4-BE49-F238E27FC236}">
                <a16:creationId xmlns:a16="http://schemas.microsoft.com/office/drawing/2014/main" id="{414F566B-A978-DE42-948D-97BBAE37BC2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30267" y="359922"/>
            <a:ext cx="9731465" cy="44844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Rectangle 11">
            <a:extLst>
              <a:ext uri="{FF2B5EF4-FFF2-40B4-BE49-F238E27FC236}">
                <a16:creationId xmlns:a16="http://schemas.microsoft.com/office/drawing/2014/main" id="{8BDBA5EC-F0E7-15AA-BD2C-EA0C11247B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11" name="Rectangle 12">
            <a:extLst>
              <a:ext uri="{FF2B5EF4-FFF2-40B4-BE49-F238E27FC236}">
                <a16:creationId xmlns:a16="http://schemas.microsoft.com/office/drawing/2014/main" id="{D2D3417F-1D08-7D4A-46A2-B9A38C1934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03506" y="5270930"/>
            <a:ext cx="10293202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8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. </a:t>
            </a:r>
            <a:r>
              <a:rPr lang="en-US" sz="180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1</a:t>
            </a:r>
            <a:r>
              <a:rPr kumimoji="0" lang="en-US" altLang="en-US" sz="1800" b="1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</a:rPr>
              <a:t>. </a:t>
            </a:r>
            <a:r>
              <a:rPr kumimoji="0" lang="en-US" altLang="en-US" sz="1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</a:rPr>
              <a:t>The illustration of developed software using Gaussian Process Regression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60F4C40-7734-0B74-1D17-5F12B1CC624B}"/>
              </a:ext>
            </a:extLst>
          </p:cNvPr>
          <p:cNvSpPr txBox="1"/>
          <p:nvPr/>
        </p:nvSpPr>
        <p:spPr>
          <a:xfrm>
            <a:off x="683367" y="6240453"/>
            <a:ext cx="609437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1300127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5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Palatino Linotyp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Fatih Tarlak</dc:creator>
  <cp:lastModifiedBy>MDPI</cp:lastModifiedBy>
  <cp:revision>2</cp:revision>
  <dcterms:created xsi:type="dcterms:W3CDTF">2025-01-26T10:15:10Z</dcterms:created>
  <dcterms:modified xsi:type="dcterms:W3CDTF">2025-02-06T03:37:52Z</dcterms:modified>
</cp:coreProperties>
</file>